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5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5" autoAdjust="0"/>
    <p:restoredTop sz="96433" autoAdjust="0"/>
  </p:normalViewPr>
  <p:slideViewPr>
    <p:cSldViewPr snapToGrid="0">
      <p:cViewPr varScale="1">
        <p:scale>
          <a:sx n="65" d="100"/>
          <a:sy n="65" d="100"/>
        </p:scale>
        <p:origin x="102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cdenver.pvt\som\Endo\RES-Lab\TJ%20Beadnell\Experiments\KDS\KDS_Combo\Clonogenic\3%20day%20treatment\Quantification%203%20day%20treatment%208505C%20C643%20KDS%20combo%20AT7867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cdenver.pvt\som\Endo\RES-Lab\TJ%20Beadnell\Experiments\KDS\KDS_Combo\Clonogenic\3%20day%20treatment\Quantification%203%20day%20treatment%208505C%20C643%20KDS%20combo%20AT7867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T$29:$T$44</c:f>
                <c:numCache>
                  <c:formatCode>General</c:formatCode>
                  <c:ptCount val="16"/>
                  <c:pt idx="0">
                    <c:v>5.3477157896746765E-2</c:v>
                  </c:pt>
                  <c:pt idx="1">
                    <c:v>5.5595900665887099E-2</c:v>
                  </c:pt>
                  <c:pt idx="2">
                    <c:v>0.1662994640509366</c:v>
                  </c:pt>
                  <c:pt idx="3">
                    <c:v>3.1413115156745906E-2</c:v>
                  </c:pt>
                  <c:pt idx="4">
                    <c:v>3.2730414027976593E-2</c:v>
                  </c:pt>
                  <c:pt idx="5">
                    <c:v>4.9433959214339109E-2</c:v>
                  </c:pt>
                  <c:pt idx="6">
                    <c:v>5.1356714834885769E-2</c:v>
                  </c:pt>
                  <c:pt idx="7">
                    <c:v>2.2541167903161533E-2</c:v>
                  </c:pt>
                  <c:pt idx="8">
                    <c:v>2.75840280244595E-2</c:v>
                  </c:pt>
                  <c:pt idx="9">
                    <c:v>0.13912073764858421</c:v>
                  </c:pt>
                  <c:pt idx="10">
                    <c:v>2.0057200599147913E-2</c:v>
                  </c:pt>
                  <c:pt idx="11">
                    <c:v>9.6004036980924093E-2</c:v>
                  </c:pt>
                  <c:pt idx="12">
                    <c:v>0.16596581704728955</c:v>
                  </c:pt>
                  <c:pt idx="13">
                    <c:v>4.4438131207581263E-2</c:v>
                  </c:pt>
                  <c:pt idx="14">
                    <c:v>0.11689073177427536</c:v>
                  </c:pt>
                  <c:pt idx="15">
                    <c:v>1.3353225505142672E-2</c:v>
                  </c:pt>
                </c:numCache>
              </c:numRef>
            </c:plus>
            <c:minus>
              <c:numRef>
                <c:f>Sheet1!$T$29:$T$44</c:f>
                <c:numCache>
                  <c:formatCode>General</c:formatCode>
                  <c:ptCount val="16"/>
                  <c:pt idx="0">
                    <c:v>5.3477157896746765E-2</c:v>
                  </c:pt>
                  <c:pt idx="1">
                    <c:v>5.5595900665887099E-2</c:v>
                  </c:pt>
                  <c:pt idx="2">
                    <c:v>0.1662994640509366</c:v>
                  </c:pt>
                  <c:pt idx="3">
                    <c:v>3.1413115156745906E-2</c:v>
                  </c:pt>
                  <c:pt idx="4">
                    <c:v>3.2730414027976593E-2</c:v>
                  </c:pt>
                  <c:pt idx="5">
                    <c:v>4.9433959214339109E-2</c:v>
                  </c:pt>
                  <c:pt idx="6">
                    <c:v>5.1356714834885769E-2</c:v>
                  </c:pt>
                  <c:pt idx="7">
                    <c:v>2.2541167903161533E-2</c:v>
                  </c:pt>
                  <c:pt idx="8">
                    <c:v>2.75840280244595E-2</c:v>
                  </c:pt>
                  <c:pt idx="9">
                    <c:v>0.13912073764858421</c:v>
                  </c:pt>
                  <c:pt idx="10">
                    <c:v>2.0057200599147913E-2</c:v>
                  </c:pt>
                  <c:pt idx="11">
                    <c:v>9.6004036980924093E-2</c:v>
                  </c:pt>
                  <c:pt idx="12">
                    <c:v>0.16596581704728955</c:v>
                  </c:pt>
                  <c:pt idx="13">
                    <c:v>4.4438131207581263E-2</c:v>
                  </c:pt>
                  <c:pt idx="14">
                    <c:v>0.11689073177427536</c:v>
                  </c:pt>
                  <c:pt idx="15">
                    <c:v>1.335322550514267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Q$29:$R$36</c:f>
              <c:multiLvlStrCache>
                <c:ptCount val="8"/>
                <c:lvl>
                  <c:pt idx="0">
                    <c:v>DMSO</c:v>
                  </c:pt>
                  <c:pt idx="1">
                    <c:v>Tram</c:v>
                  </c:pt>
                  <c:pt idx="2">
                    <c:v>Das</c:v>
                  </c:pt>
                  <c:pt idx="3">
                    <c:v>Das + Tram</c:v>
                  </c:pt>
                  <c:pt idx="4">
                    <c:v>AT7867</c:v>
                  </c:pt>
                  <c:pt idx="5">
                    <c:v>AT + Tram</c:v>
                  </c:pt>
                  <c:pt idx="6">
                    <c:v>AT + Das</c:v>
                  </c:pt>
                  <c:pt idx="7">
                    <c:v>3x</c:v>
                  </c:pt>
                </c:lvl>
                <c:lvl>
                  <c:pt idx="0">
                    <c:v>C643 </c:v>
                  </c:pt>
                </c:lvl>
              </c:multiLvlStrCache>
            </c:multiLvlStrRef>
          </c:cat>
          <c:val>
            <c:numRef>
              <c:f>Sheet1!$S$29:$S$36</c:f>
              <c:numCache>
                <c:formatCode>General</c:formatCode>
                <c:ptCount val="8"/>
                <c:pt idx="0">
                  <c:v>1.0196783630537394</c:v>
                </c:pt>
                <c:pt idx="1">
                  <c:v>0.34322643984839618</c:v>
                </c:pt>
                <c:pt idx="2">
                  <c:v>0.91270708628746955</c:v>
                </c:pt>
                <c:pt idx="3">
                  <c:v>0.12641305195779343</c:v>
                </c:pt>
                <c:pt idx="4">
                  <c:v>0.40320676299642116</c:v>
                </c:pt>
                <c:pt idx="5">
                  <c:v>0.1762969813231216</c:v>
                </c:pt>
                <c:pt idx="6">
                  <c:v>0.19470161636072547</c:v>
                </c:pt>
                <c:pt idx="7">
                  <c:v>7.7181369996574059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84936600"/>
        <c:axId val="484936992"/>
      </c:barChart>
      <c:catAx>
        <c:axId val="4849366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84936992"/>
        <c:crosses val="autoZero"/>
        <c:auto val="1"/>
        <c:lblAlgn val="ctr"/>
        <c:lblOffset val="100"/>
        <c:noMultiLvlLbl val="0"/>
      </c:catAx>
      <c:valAx>
        <c:axId val="4849369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old Change</a:t>
                </a:r>
              </a:p>
              <a:p>
                <a:pPr>
                  <a:defRPr/>
                </a:pPr>
                <a:r>
                  <a:rPr lang="en-US"/>
                  <a:t> (Relative to DMSO Contro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849366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050" b="1"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Sheet1!$T$29:$T$44</c:f>
                <c:numCache>
                  <c:formatCode>General</c:formatCode>
                  <c:ptCount val="16"/>
                  <c:pt idx="0">
                    <c:v>5.3477157896746765E-2</c:v>
                  </c:pt>
                  <c:pt idx="1">
                    <c:v>5.5595900665887099E-2</c:v>
                  </c:pt>
                  <c:pt idx="2">
                    <c:v>0.1662994640509366</c:v>
                  </c:pt>
                  <c:pt idx="3">
                    <c:v>3.1413115156745906E-2</c:v>
                  </c:pt>
                  <c:pt idx="4">
                    <c:v>3.2730414027976593E-2</c:v>
                  </c:pt>
                  <c:pt idx="5">
                    <c:v>4.9433959214339109E-2</c:v>
                  </c:pt>
                  <c:pt idx="6">
                    <c:v>5.1356714834885769E-2</c:v>
                  </c:pt>
                  <c:pt idx="7">
                    <c:v>2.2541167903161533E-2</c:v>
                  </c:pt>
                  <c:pt idx="8">
                    <c:v>2.75840280244595E-2</c:v>
                  </c:pt>
                  <c:pt idx="9">
                    <c:v>0.13912073764858421</c:v>
                  </c:pt>
                  <c:pt idx="10">
                    <c:v>2.0057200599147913E-2</c:v>
                  </c:pt>
                  <c:pt idx="11">
                    <c:v>9.6004036980924093E-2</c:v>
                  </c:pt>
                  <c:pt idx="12">
                    <c:v>0.16596581704728955</c:v>
                  </c:pt>
                  <c:pt idx="13">
                    <c:v>4.4438131207581263E-2</c:v>
                  </c:pt>
                  <c:pt idx="14">
                    <c:v>0.11689073177427536</c:v>
                  </c:pt>
                  <c:pt idx="15">
                    <c:v>1.3353225505142672E-2</c:v>
                  </c:pt>
                </c:numCache>
              </c:numRef>
            </c:plus>
            <c:minus>
              <c:numRef>
                <c:f>Sheet1!$T$29:$T$44</c:f>
                <c:numCache>
                  <c:formatCode>General</c:formatCode>
                  <c:ptCount val="16"/>
                  <c:pt idx="0">
                    <c:v>5.3477157896746765E-2</c:v>
                  </c:pt>
                  <c:pt idx="1">
                    <c:v>5.5595900665887099E-2</c:v>
                  </c:pt>
                  <c:pt idx="2">
                    <c:v>0.1662994640509366</c:v>
                  </c:pt>
                  <c:pt idx="3">
                    <c:v>3.1413115156745906E-2</c:v>
                  </c:pt>
                  <c:pt idx="4">
                    <c:v>3.2730414027976593E-2</c:v>
                  </c:pt>
                  <c:pt idx="5">
                    <c:v>4.9433959214339109E-2</c:v>
                  </c:pt>
                  <c:pt idx="6">
                    <c:v>5.1356714834885769E-2</c:v>
                  </c:pt>
                  <c:pt idx="7">
                    <c:v>2.2541167903161533E-2</c:v>
                  </c:pt>
                  <c:pt idx="8">
                    <c:v>2.75840280244595E-2</c:v>
                  </c:pt>
                  <c:pt idx="9">
                    <c:v>0.13912073764858421</c:v>
                  </c:pt>
                  <c:pt idx="10">
                    <c:v>2.0057200599147913E-2</c:v>
                  </c:pt>
                  <c:pt idx="11">
                    <c:v>9.6004036980924093E-2</c:v>
                  </c:pt>
                  <c:pt idx="12">
                    <c:v>0.16596581704728955</c:v>
                  </c:pt>
                  <c:pt idx="13">
                    <c:v>4.4438131207581263E-2</c:v>
                  </c:pt>
                  <c:pt idx="14">
                    <c:v>0.11689073177427536</c:v>
                  </c:pt>
                  <c:pt idx="15">
                    <c:v>1.335322550514267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Q$37:$R$44</c:f>
              <c:multiLvlStrCache>
                <c:ptCount val="8"/>
                <c:lvl>
                  <c:pt idx="0">
                    <c:v>DMSO</c:v>
                  </c:pt>
                  <c:pt idx="1">
                    <c:v>Tram</c:v>
                  </c:pt>
                  <c:pt idx="2">
                    <c:v>Das</c:v>
                  </c:pt>
                  <c:pt idx="3">
                    <c:v>Das + Tram</c:v>
                  </c:pt>
                  <c:pt idx="4">
                    <c:v>AT7867</c:v>
                  </c:pt>
                  <c:pt idx="5">
                    <c:v>AT + Tram</c:v>
                  </c:pt>
                  <c:pt idx="6">
                    <c:v>AT + Das</c:v>
                  </c:pt>
                  <c:pt idx="7">
                    <c:v>3x</c:v>
                  </c:pt>
                </c:lvl>
                <c:lvl>
                  <c:pt idx="0">
                    <c:v>8505C </c:v>
                  </c:pt>
                </c:lvl>
              </c:multiLvlStrCache>
            </c:multiLvlStrRef>
          </c:cat>
          <c:val>
            <c:numRef>
              <c:f>Sheet1!$S$37:$S$44</c:f>
              <c:numCache>
                <c:formatCode>General</c:formatCode>
                <c:ptCount val="8"/>
                <c:pt idx="0">
                  <c:v>1.047353557225335</c:v>
                </c:pt>
                <c:pt idx="1">
                  <c:v>0.357263114476157</c:v>
                </c:pt>
                <c:pt idx="2">
                  <c:v>1.1485901316116589</c:v>
                </c:pt>
                <c:pt idx="3">
                  <c:v>0.22735481090477433</c:v>
                </c:pt>
                <c:pt idx="4">
                  <c:v>0.5863609201664628</c:v>
                </c:pt>
                <c:pt idx="5">
                  <c:v>0.16095618923710542</c:v>
                </c:pt>
                <c:pt idx="6">
                  <c:v>0.29586539232185377</c:v>
                </c:pt>
                <c:pt idx="7">
                  <c:v>6.9497689612531735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84937776"/>
        <c:axId val="484938168"/>
      </c:barChart>
      <c:catAx>
        <c:axId val="4849377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84938168"/>
        <c:crosses val="autoZero"/>
        <c:auto val="1"/>
        <c:lblAlgn val="ctr"/>
        <c:lblOffset val="100"/>
        <c:noMultiLvlLbl val="0"/>
      </c:catAx>
      <c:valAx>
        <c:axId val="48493816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old Change</a:t>
                </a:r>
              </a:p>
              <a:p>
                <a:pPr>
                  <a:defRPr/>
                </a:pPr>
                <a:r>
                  <a:rPr lang="en-US"/>
                  <a:t> (Relative to DMSO Contro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849377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050" b="1"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C643</a:t>
            </a:r>
          </a:p>
        </c:rich>
      </c:tx>
      <c:layout>
        <c:manualLayout>
          <c:xMode val="edge"/>
          <c:yMode val="edge"/>
          <c:x val="0.44506630801047037"/>
          <c:y val="0.1620286803522387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Q$3</c:f>
              <c:strCache>
                <c:ptCount val="1"/>
                <c:pt idx="0">
                  <c:v>pS6 S235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V$4:$V$1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3.4807642609041782E-2</c:v>
                  </c:pt>
                  <c:pt idx="2">
                    <c:v>8.5181680536172241E-2</c:v>
                  </c:pt>
                  <c:pt idx="3">
                    <c:v>0.13816050133214774</c:v>
                  </c:pt>
                  <c:pt idx="4">
                    <c:v>5.5445476172331455E-2</c:v>
                  </c:pt>
                  <c:pt idx="5">
                    <c:v>0.13058780300159606</c:v>
                  </c:pt>
                  <c:pt idx="6">
                    <c:v>4.6069037492513593E-2</c:v>
                  </c:pt>
                  <c:pt idx="7">
                    <c:v>5.3832283462427934E-3</c:v>
                  </c:pt>
                </c:numCache>
              </c:numRef>
            </c:plus>
            <c:minus>
              <c:numRef>
                <c:f>Sheet1!$V$4:$V$1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3.4807642609041782E-2</c:v>
                  </c:pt>
                  <c:pt idx="2">
                    <c:v>8.5181680536172241E-2</c:v>
                  </c:pt>
                  <c:pt idx="3">
                    <c:v>0.13816050133214774</c:v>
                  </c:pt>
                  <c:pt idx="4">
                    <c:v>5.5445476172331455E-2</c:v>
                  </c:pt>
                  <c:pt idx="5">
                    <c:v>0.13058780300159606</c:v>
                  </c:pt>
                  <c:pt idx="6">
                    <c:v>4.6069037492513593E-2</c:v>
                  </c:pt>
                  <c:pt idx="7">
                    <c:v>5.3832283462427934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P$4:$P$11</c:f>
              <c:strCache>
                <c:ptCount val="8"/>
                <c:pt idx="0">
                  <c:v>DMSO </c:v>
                </c:pt>
                <c:pt idx="1">
                  <c:v>Tram</c:v>
                </c:pt>
                <c:pt idx="2">
                  <c:v>Das</c:v>
                </c:pt>
                <c:pt idx="3">
                  <c:v>Das + Tram</c:v>
                </c:pt>
                <c:pt idx="4">
                  <c:v>AT7867 </c:v>
                </c:pt>
                <c:pt idx="5">
                  <c:v>A + T</c:v>
                </c:pt>
                <c:pt idx="6">
                  <c:v>A + D</c:v>
                </c:pt>
                <c:pt idx="7">
                  <c:v>A + T + D</c:v>
                </c:pt>
              </c:strCache>
            </c:strRef>
          </c:cat>
          <c:val>
            <c:numRef>
              <c:f>Sheet1!$Q$4:$Q$11</c:f>
              <c:numCache>
                <c:formatCode>General</c:formatCode>
                <c:ptCount val="8"/>
                <c:pt idx="0">
                  <c:v>1</c:v>
                </c:pt>
                <c:pt idx="1">
                  <c:v>1.7572649136556544</c:v>
                </c:pt>
                <c:pt idx="2">
                  <c:v>1.1037915132485692</c:v>
                </c:pt>
                <c:pt idx="3">
                  <c:v>0.45220298133902725</c:v>
                </c:pt>
                <c:pt idx="4">
                  <c:v>0.41185826731211006</c:v>
                </c:pt>
                <c:pt idx="5">
                  <c:v>0.36477028718408028</c:v>
                </c:pt>
                <c:pt idx="6">
                  <c:v>7.587519950026711E-2</c:v>
                </c:pt>
                <c:pt idx="7">
                  <c:v>3.5305652665218852E-2</c:v>
                </c:pt>
              </c:numCache>
            </c:numRef>
          </c:val>
        </c:ser>
        <c:ser>
          <c:idx val="1"/>
          <c:order val="1"/>
          <c:tx>
            <c:strRef>
              <c:f>Sheet1!$R$3</c:f>
              <c:strCache>
                <c:ptCount val="1"/>
                <c:pt idx="0">
                  <c:v>pS6 S240</c:v>
                </c:pt>
              </c:strCache>
            </c:strRef>
          </c:tx>
          <c:spPr>
            <a:pattFill prst="dkDnDiag">
              <a:fgClr>
                <a:schemeClr val="accent1"/>
              </a:fgClr>
              <a:bgClr>
                <a:schemeClr val="bg1"/>
              </a:bgClr>
            </a:pattFill>
            <a:ln>
              <a:solidFill>
                <a:schemeClr val="accent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W$4:$W$1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4.6691364015649772E-2</c:v>
                  </c:pt>
                  <c:pt idx="2">
                    <c:v>0.10570517885528471</c:v>
                  </c:pt>
                  <c:pt idx="3">
                    <c:v>0.13044582146486461</c:v>
                  </c:pt>
                  <c:pt idx="4">
                    <c:v>3.2992958661431308E-2</c:v>
                  </c:pt>
                  <c:pt idx="5">
                    <c:v>7.9645070838252743E-2</c:v>
                  </c:pt>
                  <c:pt idx="6">
                    <c:v>1.611303303933484E-2</c:v>
                  </c:pt>
                  <c:pt idx="7">
                    <c:v>2.1127805072086621E-2</c:v>
                  </c:pt>
                </c:numCache>
              </c:numRef>
            </c:plus>
            <c:minus>
              <c:numRef>
                <c:f>Sheet1!$W$4:$W$1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4.6691364015649772E-2</c:v>
                  </c:pt>
                  <c:pt idx="2">
                    <c:v>0.10570517885528471</c:v>
                  </c:pt>
                  <c:pt idx="3">
                    <c:v>0.13044582146486461</c:v>
                  </c:pt>
                  <c:pt idx="4">
                    <c:v>3.2992958661431308E-2</c:v>
                  </c:pt>
                  <c:pt idx="5">
                    <c:v>7.9645070838252743E-2</c:v>
                  </c:pt>
                  <c:pt idx="6">
                    <c:v>1.611303303933484E-2</c:v>
                  </c:pt>
                  <c:pt idx="7">
                    <c:v>2.112780507208662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P$4:$P$11</c:f>
              <c:strCache>
                <c:ptCount val="8"/>
                <c:pt idx="0">
                  <c:v>DMSO </c:v>
                </c:pt>
                <c:pt idx="1">
                  <c:v>Tram</c:v>
                </c:pt>
                <c:pt idx="2">
                  <c:v>Das</c:v>
                </c:pt>
                <c:pt idx="3">
                  <c:v>Das + Tram</c:v>
                </c:pt>
                <c:pt idx="4">
                  <c:v>AT7867 </c:v>
                </c:pt>
                <c:pt idx="5">
                  <c:v>A + T</c:v>
                </c:pt>
                <c:pt idx="6">
                  <c:v>A + D</c:v>
                </c:pt>
                <c:pt idx="7">
                  <c:v>A + T + D</c:v>
                </c:pt>
              </c:strCache>
            </c:strRef>
          </c:cat>
          <c:val>
            <c:numRef>
              <c:f>Sheet1!$R$4:$R$11</c:f>
              <c:numCache>
                <c:formatCode>General</c:formatCode>
                <c:ptCount val="8"/>
                <c:pt idx="0">
                  <c:v>1</c:v>
                </c:pt>
                <c:pt idx="1">
                  <c:v>0.9641264208196022</c:v>
                </c:pt>
                <c:pt idx="2">
                  <c:v>0.60062877377887947</c:v>
                </c:pt>
                <c:pt idx="3">
                  <c:v>0.56747878849783184</c:v>
                </c:pt>
                <c:pt idx="4">
                  <c:v>0.31229574006893546</c:v>
                </c:pt>
                <c:pt idx="5">
                  <c:v>0.30686614521841793</c:v>
                </c:pt>
                <c:pt idx="6">
                  <c:v>0.15009802862627222</c:v>
                </c:pt>
                <c:pt idx="7">
                  <c:v>0.108232619449628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89982264"/>
        <c:axId val="289980696"/>
      </c:barChart>
      <c:catAx>
        <c:axId val="289982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89980696"/>
        <c:crosses val="autoZero"/>
        <c:auto val="1"/>
        <c:lblAlgn val="ctr"/>
        <c:lblOffset val="100"/>
        <c:noMultiLvlLbl val="0"/>
      </c:catAx>
      <c:valAx>
        <c:axId val="28998069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old Change Densitometry</a:t>
                </a:r>
              </a:p>
              <a:p>
                <a:pPr>
                  <a:defRPr/>
                </a:pPr>
                <a:r>
                  <a:rPr lang="en-US"/>
                  <a:t> (Normalized to DMSO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899822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8505C</a:t>
            </a:r>
          </a:p>
        </c:rich>
      </c:tx>
      <c:layout>
        <c:manualLayout>
          <c:xMode val="edge"/>
          <c:yMode val="edge"/>
          <c:x val="0.45173600174978124"/>
          <c:y val="2.777777777777777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Q$3</c:f>
              <c:strCache>
                <c:ptCount val="1"/>
                <c:pt idx="0">
                  <c:v>pS6 S235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V$4:$V$1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3.4807642609041782E-2</c:v>
                  </c:pt>
                  <c:pt idx="2">
                    <c:v>8.5181680536172241E-2</c:v>
                  </c:pt>
                  <c:pt idx="3">
                    <c:v>0.13816050133214774</c:v>
                  </c:pt>
                  <c:pt idx="4">
                    <c:v>5.5445476172331455E-2</c:v>
                  </c:pt>
                  <c:pt idx="5">
                    <c:v>0.13058780300159606</c:v>
                  </c:pt>
                  <c:pt idx="6">
                    <c:v>4.6069037492513593E-2</c:v>
                  </c:pt>
                  <c:pt idx="7">
                    <c:v>5.3832283462427934E-3</c:v>
                  </c:pt>
                </c:numCache>
              </c:numRef>
            </c:plus>
            <c:minus>
              <c:numRef>
                <c:f>Sheet1!$V$4:$V$1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3.4807642609041782E-2</c:v>
                  </c:pt>
                  <c:pt idx="2">
                    <c:v>8.5181680536172241E-2</c:v>
                  </c:pt>
                  <c:pt idx="3">
                    <c:v>0.13816050133214774</c:v>
                  </c:pt>
                  <c:pt idx="4">
                    <c:v>5.5445476172331455E-2</c:v>
                  </c:pt>
                  <c:pt idx="5">
                    <c:v>0.13058780300159606</c:v>
                  </c:pt>
                  <c:pt idx="6">
                    <c:v>4.6069037492513593E-2</c:v>
                  </c:pt>
                  <c:pt idx="7">
                    <c:v>5.3832283462427934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P$16:$P$23</c:f>
              <c:strCache>
                <c:ptCount val="8"/>
                <c:pt idx="0">
                  <c:v>DMSO </c:v>
                </c:pt>
                <c:pt idx="1">
                  <c:v>Tram</c:v>
                </c:pt>
                <c:pt idx="2">
                  <c:v>Das</c:v>
                </c:pt>
                <c:pt idx="3">
                  <c:v>Das + Tram</c:v>
                </c:pt>
                <c:pt idx="4">
                  <c:v>AT7867 </c:v>
                </c:pt>
                <c:pt idx="5">
                  <c:v>A + T</c:v>
                </c:pt>
                <c:pt idx="6">
                  <c:v>A + D</c:v>
                </c:pt>
                <c:pt idx="7">
                  <c:v>A + T + D</c:v>
                </c:pt>
              </c:strCache>
            </c:strRef>
          </c:cat>
          <c:val>
            <c:numRef>
              <c:f>Sheet1!$Q$16:$Q$23</c:f>
              <c:numCache>
                <c:formatCode>General</c:formatCode>
                <c:ptCount val="8"/>
                <c:pt idx="0">
                  <c:v>1</c:v>
                </c:pt>
                <c:pt idx="1">
                  <c:v>0.8208684527868273</c:v>
                </c:pt>
                <c:pt idx="2">
                  <c:v>0.25641212185654816</c:v>
                </c:pt>
                <c:pt idx="3">
                  <c:v>0.24916673719941393</c:v>
                </c:pt>
                <c:pt idx="4">
                  <c:v>0.30931913050780468</c:v>
                </c:pt>
                <c:pt idx="5">
                  <c:v>0.3190877424563528</c:v>
                </c:pt>
                <c:pt idx="6">
                  <c:v>0.36278394105011286</c:v>
                </c:pt>
                <c:pt idx="7">
                  <c:v>0.13602941916642702</c:v>
                </c:pt>
              </c:numCache>
            </c:numRef>
          </c:val>
        </c:ser>
        <c:ser>
          <c:idx val="1"/>
          <c:order val="1"/>
          <c:tx>
            <c:strRef>
              <c:f>Sheet1!$R$3</c:f>
              <c:strCache>
                <c:ptCount val="1"/>
                <c:pt idx="0">
                  <c:v>pS6 S240</c:v>
                </c:pt>
              </c:strCache>
            </c:strRef>
          </c:tx>
          <c:spPr>
            <a:pattFill prst="dkDnDiag">
              <a:fgClr>
                <a:srgbClr val="FF0000"/>
              </a:fgClr>
              <a:bgClr>
                <a:schemeClr val="bg1"/>
              </a:bgClr>
            </a:pattFill>
            <a:ln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W$4:$W$1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4.6691364015649772E-2</c:v>
                  </c:pt>
                  <c:pt idx="2">
                    <c:v>0.10570517885528471</c:v>
                  </c:pt>
                  <c:pt idx="3">
                    <c:v>0.13044582146486461</c:v>
                  </c:pt>
                  <c:pt idx="4">
                    <c:v>3.2992958661431308E-2</c:v>
                  </c:pt>
                  <c:pt idx="5">
                    <c:v>7.9645070838252743E-2</c:v>
                  </c:pt>
                  <c:pt idx="6">
                    <c:v>1.611303303933484E-2</c:v>
                  </c:pt>
                  <c:pt idx="7">
                    <c:v>2.1127805072086621E-2</c:v>
                  </c:pt>
                </c:numCache>
              </c:numRef>
            </c:plus>
            <c:minus>
              <c:numRef>
                <c:f>Sheet1!$W$4:$W$1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4.6691364015649772E-2</c:v>
                  </c:pt>
                  <c:pt idx="2">
                    <c:v>0.10570517885528471</c:v>
                  </c:pt>
                  <c:pt idx="3">
                    <c:v>0.13044582146486461</c:v>
                  </c:pt>
                  <c:pt idx="4">
                    <c:v>3.2992958661431308E-2</c:v>
                  </c:pt>
                  <c:pt idx="5">
                    <c:v>7.9645070838252743E-2</c:v>
                  </c:pt>
                  <c:pt idx="6">
                    <c:v>1.611303303933484E-2</c:v>
                  </c:pt>
                  <c:pt idx="7">
                    <c:v>2.112780507208662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P$16:$P$23</c:f>
              <c:strCache>
                <c:ptCount val="8"/>
                <c:pt idx="0">
                  <c:v>DMSO </c:v>
                </c:pt>
                <c:pt idx="1">
                  <c:v>Tram</c:v>
                </c:pt>
                <c:pt idx="2">
                  <c:v>Das</c:v>
                </c:pt>
                <c:pt idx="3">
                  <c:v>Das + Tram</c:v>
                </c:pt>
                <c:pt idx="4">
                  <c:v>AT7867 </c:v>
                </c:pt>
                <c:pt idx="5">
                  <c:v>A + T</c:v>
                </c:pt>
                <c:pt idx="6">
                  <c:v>A + D</c:v>
                </c:pt>
                <c:pt idx="7">
                  <c:v>A + T + D</c:v>
                </c:pt>
              </c:strCache>
            </c:strRef>
          </c:cat>
          <c:val>
            <c:numRef>
              <c:f>Sheet1!$R$16:$R$23</c:f>
              <c:numCache>
                <c:formatCode>General</c:formatCode>
                <c:ptCount val="8"/>
                <c:pt idx="0">
                  <c:v>1</c:v>
                </c:pt>
                <c:pt idx="1">
                  <c:v>0.84932440174192292</c:v>
                </c:pt>
                <c:pt idx="2">
                  <c:v>0.54800732000539565</c:v>
                </c:pt>
                <c:pt idx="3">
                  <c:v>0.24537895410483027</c:v>
                </c:pt>
                <c:pt idx="4">
                  <c:v>0.66019328459204107</c:v>
                </c:pt>
                <c:pt idx="5">
                  <c:v>0.37676153325054651</c:v>
                </c:pt>
                <c:pt idx="6">
                  <c:v>0.43577064177598829</c:v>
                </c:pt>
                <c:pt idx="7">
                  <c:v>0.178321353205895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84939344"/>
        <c:axId val="484939736"/>
      </c:barChart>
      <c:catAx>
        <c:axId val="4849393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84939736"/>
        <c:crosses val="autoZero"/>
        <c:auto val="1"/>
        <c:lblAlgn val="ctr"/>
        <c:lblOffset val="100"/>
        <c:noMultiLvlLbl val="0"/>
      </c:catAx>
      <c:valAx>
        <c:axId val="48493973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old Change Densitometry</a:t>
                </a:r>
              </a:p>
              <a:p>
                <a:pPr>
                  <a:defRPr/>
                </a:pPr>
                <a:r>
                  <a:rPr lang="en-US"/>
                  <a:t> (Normalized to DMSO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849393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BB3CE0-A6EC-4AD1-9E4F-9645D78C58F6}" type="datetimeFigureOut">
              <a:rPr lang="en-US" smtClean="0"/>
              <a:t>5/3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9F8E10-5540-4546-AC4D-5F3C1203C6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9236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</a:t>
            </a:r>
            <a:r>
              <a:rPr lang="en-US" sz="1200" b="1" baseline="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5: Combined inhibition of </a:t>
            </a:r>
            <a:r>
              <a:rPr lang="en-US" sz="1200" b="1" baseline="0" dirty="0" err="1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rc</a:t>
            </a:r>
            <a:r>
              <a:rPr lang="en-US" sz="1200" b="1" baseline="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MEK1/2, and AKT/P70S6K. </a:t>
            </a:r>
            <a:r>
              <a:rPr lang="en-US" sz="1200" b="0" baseline="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 </a:t>
            </a:r>
            <a:r>
              <a:rPr lang="en-US" sz="12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ensitometry quantification of rpS6 phosphorylation at S235/236 and S240/S244 in the</a:t>
            </a:r>
            <a:r>
              <a:rPr lang="en-US" sz="1200" baseline="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8505C and C643</a:t>
            </a:r>
            <a:r>
              <a:rPr lang="en-US" sz="1200" baseline="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ell lines following a 4 hour treatment with 100nM </a:t>
            </a:r>
            <a:r>
              <a:rPr lang="en-US" sz="1200" dirty="0" err="1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rametinib</a:t>
            </a:r>
            <a:r>
              <a:rPr lang="en-US" sz="12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100nM </a:t>
            </a:r>
            <a:r>
              <a:rPr lang="en-US" sz="1200" dirty="0" err="1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satinib</a:t>
            </a:r>
            <a:r>
              <a:rPr lang="en-US" sz="12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</a:t>
            </a:r>
            <a:r>
              <a:rPr lang="en-US" sz="1200" baseline="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baseline="0" dirty="0" err="1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satinib</a:t>
            </a:r>
            <a:r>
              <a:rPr lang="en-US" sz="1200" baseline="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+ </a:t>
            </a:r>
            <a:r>
              <a:rPr lang="en-US" sz="1200" baseline="0" dirty="0" err="1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rametinib</a:t>
            </a:r>
            <a:r>
              <a:rPr lang="en-US" sz="12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2.5</a:t>
            </a:r>
            <a:r>
              <a:rPr lang="en-US" sz="1200" baseline="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µM AT7867, AT7867 + </a:t>
            </a:r>
            <a:r>
              <a:rPr lang="en-US" sz="1200" baseline="0" dirty="0" err="1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rametinib</a:t>
            </a:r>
            <a:r>
              <a:rPr lang="en-US" sz="1200" baseline="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AT7867 + </a:t>
            </a:r>
            <a:r>
              <a:rPr lang="en-US" sz="1200" baseline="0" dirty="0" err="1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satinib</a:t>
            </a:r>
            <a:r>
              <a:rPr lang="en-US" sz="1200" baseline="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AT7867 + </a:t>
            </a:r>
            <a:r>
              <a:rPr lang="en-US" sz="1200" baseline="0" dirty="0" err="1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satinib</a:t>
            </a:r>
            <a:r>
              <a:rPr lang="en-US" sz="1200" baseline="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+ </a:t>
            </a:r>
            <a:r>
              <a:rPr lang="en-US" sz="1200" baseline="0" dirty="0" err="1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rametinib</a:t>
            </a:r>
            <a:r>
              <a:rPr lang="en-US" sz="1200" baseline="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</a:t>
            </a:r>
            <a:r>
              <a:rPr lang="en-US" sz="12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r an equivalent amount of DMSO. </a:t>
            </a:r>
            <a:r>
              <a:rPr lang="en-US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as means +/- SEM (n=3).</a:t>
            </a:r>
            <a:r>
              <a:rPr lang="en-US" sz="12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b="0" baseline="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200" baseline="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cells were treated with either DMSO, 100nM </a:t>
            </a:r>
            <a:r>
              <a:rPr lang="en-US" sz="1200" dirty="0" err="1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ametinib</a:t>
            </a:r>
            <a:r>
              <a:rPr lang="en-US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100nM </a:t>
            </a:r>
            <a:r>
              <a:rPr lang="en-US" sz="1200" dirty="0" err="1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satinib</a:t>
            </a:r>
            <a:r>
              <a:rPr lang="en-US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2.5μM AT7867, </a:t>
            </a:r>
            <a:r>
              <a:rPr lang="en-US" sz="1200" dirty="0" err="1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ametinib</a:t>
            </a:r>
            <a:r>
              <a:rPr lang="en-US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+ AT7867, </a:t>
            </a:r>
            <a:r>
              <a:rPr lang="en-US" sz="1200" dirty="0" err="1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satinib</a:t>
            </a:r>
            <a:r>
              <a:rPr lang="en-US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+ AT7867, or </a:t>
            </a:r>
            <a:r>
              <a:rPr lang="en-US" sz="1200" dirty="0" err="1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ametinib</a:t>
            </a:r>
            <a:r>
              <a:rPr lang="en-US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+ </a:t>
            </a:r>
            <a:r>
              <a:rPr lang="en-US" sz="1200" dirty="0" err="1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satinib</a:t>
            </a:r>
            <a:r>
              <a:rPr lang="en-US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+ AT7867 for 3 days. Following 3 days of treatment, the cells were released for an additional 6 days. Colony area signal intensity was measured using Odyssey </a:t>
            </a:r>
            <a:r>
              <a:rPr lang="en-US" sz="1200" dirty="0" err="1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Lx</a:t>
            </a:r>
            <a:r>
              <a:rPr lang="en-US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mager (Li-</a:t>
            </a:r>
            <a:r>
              <a:rPr lang="en-US" sz="1200" dirty="0" err="1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r</a:t>
            </a:r>
            <a:r>
              <a:rPr lang="en-US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, and presented as percent fold change relative to the DMSO treated wells. Data as means +/- SEM (n=3). 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59F8E10-5540-4546-AC4D-5F3C1203C6A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9106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5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0375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5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130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5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513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5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7226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5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7499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5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90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5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2157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5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625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5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9132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5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508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5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8284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BF9B6A-0285-4DA3-9F8D-725F6014316E}" type="datetimeFigureOut">
              <a:rPr lang="en-US" smtClean="0"/>
              <a:t>5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9297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00487" y="8596120"/>
            <a:ext cx="5915025" cy="547880"/>
          </a:xfrm>
        </p:spPr>
        <p:txBody>
          <a:bodyPr>
            <a:normAutofit/>
          </a:bodyPr>
          <a:lstStyle/>
          <a:p>
            <a:r>
              <a:rPr lang="en-US" sz="2400" dirty="0" smtClean="0"/>
              <a:t>Supplemental Figure 5</a:t>
            </a:r>
            <a:endParaRPr lang="en-US" sz="2400" dirty="0"/>
          </a:p>
        </p:txBody>
      </p:sp>
      <p:grpSp>
        <p:nvGrpSpPr>
          <p:cNvPr id="5" name="Group 4"/>
          <p:cNvGrpSpPr/>
          <p:nvPr/>
        </p:nvGrpSpPr>
        <p:grpSpPr>
          <a:xfrm>
            <a:off x="284369" y="4921552"/>
            <a:ext cx="3433262" cy="4070726"/>
            <a:chOff x="404812" y="1451769"/>
            <a:chExt cx="4572000" cy="5406230"/>
          </a:xfrm>
        </p:grpSpPr>
        <p:graphicFrame>
          <p:nvGraphicFramePr>
            <p:cNvPr id="3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93825069"/>
                </p:ext>
              </p:extLst>
            </p:nvPr>
          </p:nvGraphicFramePr>
          <p:xfrm>
            <a:off x="404812" y="1451769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88856401"/>
                </p:ext>
              </p:extLst>
            </p:nvPr>
          </p:nvGraphicFramePr>
          <p:xfrm>
            <a:off x="404812" y="4114800"/>
            <a:ext cx="4572000" cy="27431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  <p:grpSp>
        <p:nvGrpSpPr>
          <p:cNvPr id="8" name="Group 7"/>
          <p:cNvGrpSpPr/>
          <p:nvPr/>
        </p:nvGrpSpPr>
        <p:grpSpPr>
          <a:xfrm>
            <a:off x="-4263" y="547880"/>
            <a:ext cx="4010526" cy="3954213"/>
            <a:chOff x="6096000" y="365125"/>
            <a:chExt cx="4572000" cy="5125566"/>
          </a:xfrm>
        </p:grpSpPr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73721010"/>
                </p:ext>
              </p:extLst>
            </p:nvPr>
          </p:nvGraphicFramePr>
          <p:xfrm>
            <a:off x="6096000" y="2747492"/>
            <a:ext cx="4572000" cy="27431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7" name="Chart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68613360"/>
                </p:ext>
              </p:extLst>
            </p:nvPr>
          </p:nvGraphicFramePr>
          <p:xfrm>
            <a:off x="6096000" y="365125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</p:grpSp>
      <p:sp>
        <p:nvSpPr>
          <p:cNvPr id="9" name="TextBox 8"/>
          <p:cNvSpPr txBox="1"/>
          <p:nvPr/>
        </p:nvSpPr>
        <p:spPr>
          <a:xfrm>
            <a:off x="-4263" y="645824"/>
            <a:ext cx="2904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A</a:t>
            </a:r>
            <a:r>
              <a:rPr lang="en-US" sz="1000" dirty="0" smtClean="0"/>
              <a:t>.</a:t>
            </a:r>
            <a:endParaRPr lang="en-US" sz="1000" dirty="0"/>
          </a:p>
        </p:txBody>
      </p:sp>
      <p:sp>
        <p:nvSpPr>
          <p:cNvPr id="10" name="TextBox 9"/>
          <p:cNvSpPr txBox="1"/>
          <p:nvPr/>
        </p:nvSpPr>
        <p:spPr>
          <a:xfrm>
            <a:off x="20224" y="4921552"/>
            <a:ext cx="2872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B</a:t>
            </a:r>
            <a:r>
              <a:rPr lang="en-US" sz="1000" dirty="0" smtClean="0"/>
              <a:t>.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3770933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3</TotalTime>
  <Words>213</Words>
  <Application>Microsoft Office PowerPoint</Application>
  <PresentationFormat>Letter Paper (8.5x11 in)</PresentationFormat>
  <Paragraphs>1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Supplemental Figure 5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adnell, Thomas</dc:creator>
  <cp:lastModifiedBy>Beadnell, Thomas</cp:lastModifiedBy>
  <cp:revision>53</cp:revision>
  <dcterms:created xsi:type="dcterms:W3CDTF">2017-05-01T20:54:24Z</dcterms:created>
  <dcterms:modified xsi:type="dcterms:W3CDTF">2017-05-30T17:28:46Z</dcterms:modified>
</cp:coreProperties>
</file>